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338" r:id="rId2"/>
    <p:sldId id="339" r:id="rId3"/>
    <p:sldId id="340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017"/>
    <p:restoredTop sz="92824"/>
  </p:normalViewPr>
  <p:slideViewPr>
    <p:cSldViewPr snapToGrid="0" snapToObjects="1">
      <p:cViewPr varScale="1">
        <p:scale>
          <a:sx n="108" d="100"/>
          <a:sy n="108" d="100"/>
        </p:scale>
        <p:origin x="-474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D37DE5-B76D-594C-9720-19C413A77CC2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9DF87A-0597-8146-8E3E-AE612BCAEBE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74050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6EA17359-0F3D-AC49-B571-33E73C3365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0CFC5A0F-4C3F-E947-8976-3514FA54EE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82C99570-786B-C448-A6BE-35CD1D82D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64B87086-B15B-7D46-9C54-01B3289F1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F8D76C5E-ED51-D947-9660-D9B21EEBE1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0872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7B8C6537-14BC-784D-9CCC-E6CA18C99A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26FF9945-8594-6244-ADE6-0475A204B0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6F5F549A-5E68-264F-B5B1-CC88DB23C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101FC360-F52F-4048-84AF-9F6312842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72B739A3-9855-7645-AB59-06A12DD0F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7362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928CE57C-8836-724B-952A-98EDC1BDA7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3B9FD2BE-ACFB-0140-BC6C-9022DED6AE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7007B03C-EB5F-9A40-A7C3-FB59E7570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A482FBFE-1605-A942-A6B6-2BB304AC6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16A3FA9E-8DB2-6743-AC50-3D0E74892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10644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30902373-3901-4645-846C-B2DCF3855F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B4350E3D-B87C-D449-BCD5-AB9DC9F18C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0006062E-0E0D-454D-8C58-2ED13F87B7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7BB0ADD0-B3F7-5D43-96C6-4E49E9307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D1ED44FA-2F62-1940-B54B-08EF56398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3260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1011B321-0AC7-F64F-9310-47B787B08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2E9BEFF5-4E5C-724A-B68C-9EDFB9068E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1AF111F4-8B36-F946-99D8-76E97BD8A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F12984E5-4F53-A440-9D90-9983DA26D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78F1151A-F8A7-5748-B254-5E1CB49E6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3873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E09D2949-BFA5-6649-9520-5B30AAAFF1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3E0EE005-79A7-9544-93FF-06FE6D033E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70ACE90B-D8AB-B441-ACF1-A0B2AEB588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FA83AFEC-5CDA-2F44-9771-8401D5534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054CC682-FFA3-C947-A517-42053FF03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A61D0D7C-C613-954D-87D3-78194E1EE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7999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FB693CBE-8E54-A24C-97DC-B5A47FFAC8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FE6EC33B-7A91-4347-8170-7D6AD74150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95869D42-F3AE-1942-A861-049E1C32E6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F7A10998-8AEA-DB43-9F95-15DD8115A7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21BB41E2-AB07-FE45-83CF-C1DD280990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CFE2ADB6-ABAB-B04D-8FEE-42F76441E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25F02803-5CD3-AD47-A454-8468BA82B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2F451020-1654-DD43-976D-17545438C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3043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FEA09952-1309-C34F-8A58-D35E3F2C6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A1931B59-DB75-6E40-8E6B-69338D4A55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960D4603-01BC-A04B-B00C-87BF3B471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3BA9CB7E-C3E1-7D41-BCAB-16E0E367B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396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C29D4D17-F32D-464D-AACF-E20CCE2EF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DA09F8BB-6E61-3A41-B316-23B2364D2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EDC8A36C-7A32-F944-BCEE-CA5B641B4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5201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80DFBB03-6E16-7E4D-B6A6-56926A842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20B7E87A-B59E-2946-9434-43DF196DFB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F8BB4410-6E00-FB46-A77C-B6ABED52F0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C002DD5A-7FE8-F840-AB54-643E46DC8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54155CD9-8989-D743-9179-AF591834C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11F09367-A160-5140-A198-B7E36B962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920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DADD1996-1A2F-BB4D-842D-345D67D10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95635903-BC03-0A48-A081-782EC29E91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95372F17-A60E-7249-A321-2E211BB581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0306974E-80D8-3A41-AE33-372170B6E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D706E4A3-D293-9646-BD88-32E173676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65C24B7E-6766-D044-9E40-F9A06CF29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3425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65158F39-10E4-354A-B755-B0198F032F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99822286-3A4F-AA4E-AF68-BE2C2E6942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977507C7-870F-6B46-AB4B-69803831AF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99632-3C58-C74C-BA46-A9C6E778DE5A}" type="datetimeFigureOut">
              <a:rPr lang="de-DE" smtClean="0"/>
              <a:t>31.12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093214B8-9258-2A4D-BFF6-2027F514ED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B02AE9D0-3B50-CF44-8042-41F49999E8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65F335-3275-F34F-AD93-FFEC8AE799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185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8" descr="A close-up of a white surface&#10;&#10;Description automatically generated">
            <a:extLst>
              <a:ext uri="{FF2B5EF4-FFF2-40B4-BE49-F238E27FC236}">
                <a16:creationId xmlns:a16="http://schemas.microsoft.com/office/drawing/2014/main" xmlns="" id="{0B691D46-5CC1-A244-BE0C-5C4FA8FE1D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11"/>
          <a:stretch/>
        </p:blipFill>
        <p:spPr>
          <a:xfrm>
            <a:off x="576265" y="1050025"/>
            <a:ext cx="3413334" cy="2880000"/>
          </a:xfrm>
          <a:prstGeom prst="rect">
            <a:avLst/>
          </a:prstGeom>
        </p:spPr>
      </p:pic>
      <p:sp>
        <p:nvSpPr>
          <p:cNvPr id="13" name="TextBox 1">
            <a:extLst>
              <a:ext uri="{FF2B5EF4-FFF2-40B4-BE49-F238E27FC236}">
                <a16:creationId xmlns:a16="http://schemas.microsoft.com/office/drawing/2014/main" xmlns="" id="{7915760C-3852-3043-AA0A-B72F7E0DE2AB}"/>
              </a:ext>
            </a:extLst>
          </p:cNvPr>
          <p:cNvSpPr txBox="1"/>
          <p:nvPr/>
        </p:nvSpPr>
        <p:spPr>
          <a:xfrm>
            <a:off x="3161" y="12702"/>
            <a:ext cx="29101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x-none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feld 2">
            <a:extLst>
              <a:ext uri="{FF2B5EF4-FFF2-40B4-BE49-F238E27FC236}">
                <a16:creationId xmlns:a16="http://schemas.microsoft.com/office/drawing/2014/main" xmlns="" id="{8C81859A-5754-7B4B-8726-F1B12B85A76A}"/>
              </a:ext>
            </a:extLst>
          </p:cNvPr>
          <p:cNvSpPr txBox="1"/>
          <p:nvPr/>
        </p:nvSpPr>
        <p:spPr>
          <a:xfrm>
            <a:off x="1771542" y="704465"/>
            <a:ext cx="1022780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pt-P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eCAF11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Content Placeholder 4" descr="A close-up of a microscope&#10;&#10;Description automatically generated">
            <a:extLst>
              <a:ext uri="{FF2B5EF4-FFF2-40B4-BE49-F238E27FC236}">
                <a16:creationId xmlns:a16="http://schemas.microsoft.com/office/drawing/2014/main" xmlns="" id="{B867B11D-BFCC-CD43-8BD8-F6120DCD40C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11"/>
          <a:stretch/>
        </p:blipFill>
        <p:spPr>
          <a:xfrm>
            <a:off x="4186255" y="1050025"/>
            <a:ext cx="3413322" cy="2880000"/>
          </a:xfrm>
          <a:prstGeom prst="rect">
            <a:avLst/>
          </a:prstGeom>
        </p:spPr>
      </p:pic>
      <p:sp>
        <p:nvSpPr>
          <p:cNvPr id="19" name="Textfeld 2">
            <a:extLst>
              <a:ext uri="{FF2B5EF4-FFF2-40B4-BE49-F238E27FC236}">
                <a16:creationId xmlns:a16="http://schemas.microsoft.com/office/drawing/2014/main" xmlns="" id="{2A7ED7B2-F3BB-644C-ABF2-7252C695D4F4}"/>
              </a:ext>
            </a:extLst>
          </p:cNvPr>
          <p:cNvSpPr txBox="1"/>
          <p:nvPr/>
        </p:nvSpPr>
        <p:spPr>
          <a:xfrm>
            <a:off x="5376588" y="704465"/>
            <a:ext cx="1032655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pt-P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eCAF18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6289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>
            <a:extLst>
              <a:ext uri="{FF2B5EF4-FFF2-40B4-BE49-F238E27FC236}">
                <a16:creationId xmlns:a16="http://schemas.microsoft.com/office/drawing/2014/main" xmlns="" id="{A28187BB-597C-BB48-BCE1-BE77462A4646}"/>
              </a:ext>
            </a:extLst>
          </p:cNvPr>
          <p:cNvSpPr txBox="1"/>
          <p:nvPr/>
        </p:nvSpPr>
        <p:spPr>
          <a:xfrm>
            <a:off x="3161" y="12702"/>
            <a:ext cx="29101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x-none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xmlns="" id="{79CD5906-4B98-484C-94B3-163D9342A8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455" y="335867"/>
            <a:ext cx="2870200" cy="3517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6216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1">
            <a:extLst>
              <a:ext uri="{FF2B5EF4-FFF2-40B4-BE49-F238E27FC236}">
                <a16:creationId xmlns:a16="http://schemas.microsoft.com/office/drawing/2014/main" xmlns="" id="{899E2A17-BE00-7040-9518-178D31E1E9F2}"/>
              </a:ext>
            </a:extLst>
          </p:cNvPr>
          <p:cNvSpPr txBox="1"/>
          <p:nvPr/>
        </p:nvSpPr>
        <p:spPr>
          <a:xfrm>
            <a:off x="3161" y="12702"/>
            <a:ext cx="29101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x-none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xmlns="" id="{27E2A1C6-B786-4B4D-A24B-3B94857089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2617" y="139700"/>
            <a:ext cx="6159500" cy="6578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2956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1</Words>
  <Application>Microsoft Office PowerPoint</Application>
  <PresentationFormat>Custom</PresentationFormat>
  <Paragraphs>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Jhea Salimbagat Bacla-an</cp:lastModifiedBy>
  <cp:revision>22</cp:revision>
  <dcterms:created xsi:type="dcterms:W3CDTF">2024-05-16T08:13:24Z</dcterms:created>
  <dcterms:modified xsi:type="dcterms:W3CDTF">2024-12-30T21:23:10Z</dcterms:modified>
</cp:coreProperties>
</file>